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65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E7EAED"/>
    <a:srgbClr val="CCD2D8"/>
    <a:srgbClr val="156082"/>
    <a:srgbClr val="BAD9E4"/>
    <a:srgbClr val="94C3D4"/>
    <a:srgbClr val="1D85B3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8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jafi, Allison" userId="0304a55d-1748-4b32-895c-375cbdec2d3f" providerId="ADAL" clId="{C161F07B-6597-46E7-96BF-112504D21099}"/>
    <pc:docChg chg="delSld modSld">
      <pc:chgData name="Najafi, Allison" userId="0304a55d-1748-4b32-895c-375cbdec2d3f" providerId="ADAL" clId="{C161F07B-6597-46E7-96BF-112504D21099}" dt="2025-02-12T23:00:59.283" v="9" actId="6549"/>
      <pc:docMkLst>
        <pc:docMk/>
      </pc:docMkLst>
      <pc:sldChg chg="del">
        <pc:chgData name="Najafi, Allison" userId="0304a55d-1748-4b32-895c-375cbdec2d3f" providerId="ADAL" clId="{C161F07B-6597-46E7-96BF-112504D21099}" dt="2025-01-27T21:38:51.976" v="0" actId="47"/>
        <pc:sldMkLst>
          <pc:docMk/>
          <pc:sldMk cId="2725620228" sldId="256"/>
        </pc:sldMkLst>
      </pc:sldChg>
      <pc:sldChg chg="del">
        <pc:chgData name="Najafi, Allison" userId="0304a55d-1748-4b32-895c-375cbdec2d3f" providerId="ADAL" clId="{C161F07B-6597-46E7-96BF-112504D21099}" dt="2025-01-27T21:38:52.478" v="1" actId="47"/>
        <pc:sldMkLst>
          <pc:docMk/>
          <pc:sldMk cId="3569514842" sldId="257"/>
        </pc:sldMkLst>
      </pc:sldChg>
      <pc:sldChg chg="del">
        <pc:chgData name="Najafi, Allison" userId="0304a55d-1748-4b32-895c-375cbdec2d3f" providerId="ADAL" clId="{C161F07B-6597-46E7-96BF-112504D21099}" dt="2025-01-27T21:38:53.367" v="3" actId="47"/>
        <pc:sldMkLst>
          <pc:docMk/>
          <pc:sldMk cId="2505032853" sldId="258"/>
        </pc:sldMkLst>
      </pc:sldChg>
      <pc:sldChg chg="del">
        <pc:chgData name="Najafi, Allison" userId="0304a55d-1748-4b32-895c-375cbdec2d3f" providerId="ADAL" clId="{C161F07B-6597-46E7-96BF-112504D21099}" dt="2025-01-27T21:38:55.388" v="7" actId="47"/>
        <pc:sldMkLst>
          <pc:docMk/>
          <pc:sldMk cId="2305346892" sldId="259"/>
        </pc:sldMkLst>
      </pc:sldChg>
      <pc:sldChg chg="del">
        <pc:chgData name="Najafi, Allison" userId="0304a55d-1748-4b32-895c-375cbdec2d3f" providerId="ADAL" clId="{C161F07B-6597-46E7-96BF-112504D21099}" dt="2025-01-27T21:38:52.869" v="2" actId="47"/>
        <pc:sldMkLst>
          <pc:docMk/>
          <pc:sldMk cId="2192517872" sldId="260"/>
        </pc:sldMkLst>
      </pc:sldChg>
      <pc:sldChg chg="del">
        <pc:chgData name="Najafi, Allison" userId="0304a55d-1748-4b32-895c-375cbdec2d3f" providerId="ADAL" clId="{C161F07B-6597-46E7-96BF-112504D21099}" dt="2025-01-27T21:38:54.279" v="5" actId="47"/>
        <pc:sldMkLst>
          <pc:docMk/>
          <pc:sldMk cId="3507118384" sldId="262"/>
        </pc:sldMkLst>
      </pc:sldChg>
      <pc:sldChg chg="del">
        <pc:chgData name="Najafi, Allison" userId="0304a55d-1748-4b32-895c-375cbdec2d3f" providerId="ADAL" clId="{C161F07B-6597-46E7-96BF-112504D21099}" dt="2025-01-27T21:38:54.796" v="6" actId="47"/>
        <pc:sldMkLst>
          <pc:docMk/>
          <pc:sldMk cId="3515496556" sldId="263"/>
        </pc:sldMkLst>
      </pc:sldChg>
      <pc:sldChg chg="del">
        <pc:chgData name="Najafi, Allison" userId="0304a55d-1748-4b32-895c-375cbdec2d3f" providerId="ADAL" clId="{C161F07B-6597-46E7-96BF-112504D21099}" dt="2025-01-27T21:38:56.503" v="8" actId="47"/>
        <pc:sldMkLst>
          <pc:docMk/>
          <pc:sldMk cId="2264077816" sldId="264"/>
        </pc:sldMkLst>
      </pc:sldChg>
      <pc:sldChg chg="modSp mod">
        <pc:chgData name="Najafi, Allison" userId="0304a55d-1748-4b32-895c-375cbdec2d3f" providerId="ADAL" clId="{C161F07B-6597-46E7-96BF-112504D21099}" dt="2025-02-12T23:00:59.283" v="9" actId="6549"/>
        <pc:sldMkLst>
          <pc:docMk/>
          <pc:sldMk cId="639073537" sldId="265"/>
        </pc:sldMkLst>
        <pc:graphicFrameChg chg="modGraphic">
          <ac:chgData name="Najafi, Allison" userId="0304a55d-1748-4b32-895c-375cbdec2d3f" providerId="ADAL" clId="{C161F07B-6597-46E7-96BF-112504D21099}" dt="2025-02-12T23:00:59.283" v="9" actId="6549"/>
          <ac:graphicFrameMkLst>
            <pc:docMk/>
            <pc:sldMk cId="639073537" sldId="265"/>
            <ac:graphicFrameMk id="5" creationId="{17C58A3B-2440-E1C9-3FAA-5A3CF6B00366}"/>
          </ac:graphicFrameMkLst>
        </pc:graphicFrameChg>
      </pc:sldChg>
      <pc:sldChg chg="del">
        <pc:chgData name="Najafi, Allison" userId="0304a55d-1748-4b32-895c-375cbdec2d3f" providerId="ADAL" clId="{C161F07B-6597-46E7-96BF-112504D21099}" dt="2025-01-27T21:38:53.829" v="4" actId="47"/>
        <pc:sldMkLst>
          <pc:docMk/>
          <pc:sldMk cId="1558034745" sldId="26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4D3A9-35B5-48F4-9529-65B199B619BB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A9764-E4BA-4EB9-9AD5-E4A142AF8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3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6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76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0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68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5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9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0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6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7C58A3B-2440-E1C9-3FAA-5A3CF6B003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0984837"/>
              </p:ext>
            </p:extLst>
          </p:nvPr>
        </p:nvGraphicFramePr>
        <p:xfrm>
          <a:off x="991117" y="759234"/>
          <a:ext cx="4641850" cy="4438650"/>
        </p:xfrm>
        <a:graphic>
          <a:graphicData uri="http://schemas.openxmlformats.org/drawingml/2006/table">
            <a:tbl>
              <a:tblPr firstRow="1" firstCol="1" bandRow="1"/>
              <a:tblGrid>
                <a:gridCol w="609600">
                  <a:extLst>
                    <a:ext uri="{9D8B030D-6E8A-4147-A177-3AD203B41FA5}">
                      <a16:colId xmlns:a16="http://schemas.microsoft.com/office/drawing/2014/main" val="2856234924"/>
                    </a:ext>
                  </a:extLst>
                </a:gridCol>
                <a:gridCol w="1282700">
                  <a:extLst>
                    <a:ext uri="{9D8B030D-6E8A-4147-A177-3AD203B41FA5}">
                      <a16:colId xmlns:a16="http://schemas.microsoft.com/office/drawing/2014/main" val="84366198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88269247"/>
                    </a:ext>
                  </a:extLst>
                </a:gridCol>
                <a:gridCol w="893445">
                  <a:extLst>
                    <a:ext uri="{9D8B030D-6E8A-4147-A177-3AD203B41FA5}">
                      <a16:colId xmlns:a16="http://schemas.microsoft.com/office/drawing/2014/main" val="4056436364"/>
                    </a:ext>
                  </a:extLst>
                </a:gridCol>
                <a:gridCol w="626745">
                  <a:extLst>
                    <a:ext uri="{9D8B030D-6E8A-4147-A177-3AD203B41FA5}">
                      <a16:colId xmlns:a16="http://schemas.microsoft.com/office/drawing/2014/main" val="4164713569"/>
                    </a:ext>
                  </a:extLst>
                </a:gridCol>
                <a:gridCol w="619760">
                  <a:extLst>
                    <a:ext uri="{9D8B030D-6E8A-4147-A177-3AD203B41FA5}">
                      <a16:colId xmlns:a16="http://schemas.microsoft.com/office/drawing/2014/main" val="4102232231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71520"/>
                  </a:ext>
                </a:extLst>
              </a:tr>
              <a:tr h="2984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bs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ffect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ddsRatioEst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owerC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pperC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9417847"/>
                  </a:ext>
                </a:extLst>
              </a:tr>
              <a:tr h="387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          GreenLight vs PUL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53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4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75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9883494"/>
                  </a:ext>
                </a:extLst>
              </a:tr>
              <a:tr h="387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   TURP       vs PUL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3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6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2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75491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inalpay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51213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inalage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1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1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2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32426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ostatic absces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87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4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3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8346526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adder_neck_ob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6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9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6074873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adder_disorder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5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3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9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6608089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rectile_dy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8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2561231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ress Incontinence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22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3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99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6186135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rritative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ymp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LUT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2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9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7015388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bstructive 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ymp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LUT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1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5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620481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ostatiti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1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88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0213711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rinary_Calculus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0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3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92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5171802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rinary_Retention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7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36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19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1677052"/>
                  </a:ext>
                </a:extLst>
              </a:tr>
              <a:tr h="2603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rkinson’s 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25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27</a:t>
                      </a:r>
                      <a:endParaRPr lang="en-US" sz="11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61</a:t>
                      </a:r>
                      <a:endParaRPr lang="en-US" sz="11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57914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9073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037ea0-f10b-40ae-9076-89db66a894de">
      <Terms xmlns="http://schemas.microsoft.com/office/infopath/2007/PartnerControls"/>
    </lcf76f155ced4ddcb4097134ff3c332f>
    <TaxCatchAll xmlns="08c674ba-5fce-4f45-b52a-53002431429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5E9A582350B14998924DDC17E51716" ma:contentTypeVersion="18" ma:contentTypeDescription="Create a new document." ma:contentTypeScope="" ma:versionID="96056b74b4a12ad6a139844a6ffbd153">
  <xsd:schema xmlns:xsd="http://www.w3.org/2001/XMLSchema" xmlns:xs="http://www.w3.org/2001/XMLSchema" xmlns:p="http://schemas.microsoft.com/office/2006/metadata/properties" xmlns:ns2="19037ea0-f10b-40ae-9076-89db66a894de" xmlns:ns3="08c674ba-5fce-4f45-b52a-53002431429b" targetNamespace="http://schemas.microsoft.com/office/2006/metadata/properties" ma:root="true" ma:fieldsID="32741ccdb4800b1dc5dcd9d685f98680" ns2:_="" ns3:_="">
    <xsd:import namespace="19037ea0-f10b-40ae-9076-89db66a894de"/>
    <xsd:import namespace="08c674ba-5fce-4f45-b52a-5300243142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037ea0-f10b-40ae-9076-89db66a89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description="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94f6455-2e7a-42ed-804e-66c7398b9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c674ba-5fce-4f45-b52a-53002431429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4d7f076-b0d0-40ce-a473-c236f2d5f48b}" ma:internalName="TaxCatchAll" ma:showField="CatchAllData" ma:web="08c674ba-5fce-4f45-b52a-5300243142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B79E374-0ED2-4DBF-A568-5A8D1D62EC3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1D81719-BA39-4D73-878A-4271EEAE4D7D}">
  <ds:schemaRefs>
    <ds:schemaRef ds:uri="http://schemas.microsoft.com/office/2006/metadata/properties"/>
    <ds:schemaRef ds:uri="http://schemas.microsoft.com/office/infopath/2007/PartnerControls"/>
    <ds:schemaRef ds:uri="19037ea0-f10b-40ae-9076-89db66a894de"/>
    <ds:schemaRef ds:uri="08c674ba-5fce-4f45-b52a-53002431429b"/>
  </ds:schemaRefs>
</ds:datastoreItem>
</file>

<file path=customXml/itemProps3.xml><?xml version="1.0" encoding="utf-8"?>
<ds:datastoreItem xmlns:ds="http://schemas.openxmlformats.org/officeDocument/2006/customXml" ds:itemID="{E22E1F52-6CE7-4F17-B1D5-CC492C53723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037ea0-f10b-40ae-9076-89db66a894de"/>
    <ds:schemaRef ds:uri="08c674ba-5fce-4f45-b52a-5300243142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3</TotalTime>
  <Words>120</Words>
  <Application>Microsoft Office PowerPoint</Application>
  <PresentationFormat>Letter Paper (8.5x11 in)</PresentationFormat>
  <Paragraphs>9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jafi, Allison</dc:creator>
  <cp:lastModifiedBy>Najafi, Allison</cp:lastModifiedBy>
  <cp:revision>2</cp:revision>
  <dcterms:created xsi:type="dcterms:W3CDTF">2024-08-09T21:05:57Z</dcterms:created>
  <dcterms:modified xsi:type="dcterms:W3CDTF">2025-02-12T23:01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5E9A582350B14998924DDC17E51716</vt:lpwstr>
  </property>
  <property fmtid="{D5CDD505-2E9C-101B-9397-08002B2CF9AE}" pid="3" name="MediaServiceImageTags">
    <vt:lpwstr/>
  </property>
</Properties>
</file>